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xlsx" ContentType="application/vnd.openxmlformats-officedocument.spreadsheetml.sheet"/>
  <Override PartName="/ppt/embeddings/oleObject2.xlsx" ContentType="application/vnd.openxmlformats-officedocument.spreadsheetml.sheet"/>
  <Override PartName="/ppt/media/image1.wmf" ContentType="image/x-wmf"/>
  <Override PartName="/ppt/media/image2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6858000"/>
  <p:notesSz cx="7099300" cy="102346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5DF3BC-7D3B-46AD-9196-85701A8307C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274320"/>
            <a:ext cx="61722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1600200"/>
            <a:ext cx="61722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3964320"/>
            <a:ext cx="61722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C2C8BB-C8BD-441C-9527-3C0398C6B7F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274320"/>
            <a:ext cx="61722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1600200"/>
            <a:ext cx="301176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1600200"/>
            <a:ext cx="301176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3964320"/>
            <a:ext cx="301176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3964320"/>
            <a:ext cx="301176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8A801AB-BE2E-4FE0-BE28-B9443EB960B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274320"/>
            <a:ext cx="61722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1600200"/>
            <a:ext cx="19872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1600200"/>
            <a:ext cx="19872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1600200"/>
            <a:ext cx="19872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3964320"/>
            <a:ext cx="19872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3964320"/>
            <a:ext cx="19872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3964320"/>
            <a:ext cx="19872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9DC596-5202-43CE-AF31-7A261A9EEB6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274320"/>
            <a:ext cx="61722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1600200"/>
            <a:ext cx="61722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0DE8B2-2CB2-4BA7-BBC5-0561E84D79A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274320"/>
            <a:ext cx="61722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1600200"/>
            <a:ext cx="61722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AF53D7-6E83-4F6A-A6FD-F0220C8582E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274320"/>
            <a:ext cx="61722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1600200"/>
            <a:ext cx="301176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1600200"/>
            <a:ext cx="301176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E4068F-5F0F-47B2-8570-8CC486D8926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274320"/>
            <a:ext cx="61722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CD5C37-5BD9-42AB-BAF9-85DE7EFA7E2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274320"/>
            <a:ext cx="61722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DC9090-A363-46EF-B592-C7B5B947961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274320"/>
            <a:ext cx="61722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1600200"/>
            <a:ext cx="301176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1600200"/>
            <a:ext cx="301176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3964320"/>
            <a:ext cx="301176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252840E-067C-4F78-9F3D-C176535C31A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274320"/>
            <a:ext cx="61722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1600200"/>
            <a:ext cx="301176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1600200"/>
            <a:ext cx="301176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3964320"/>
            <a:ext cx="301176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BC41DF-3966-4BA8-9E92-AE0BE2F9E46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274320"/>
            <a:ext cx="61722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1600200"/>
            <a:ext cx="301176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1600200"/>
            <a:ext cx="301176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3964320"/>
            <a:ext cx="61722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02654C-E626-4B8D-8342-3A10142CB17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274320"/>
            <a:ext cx="61722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1600200"/>
            <a:ext cx="61722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7000"/>
          </a:bodyPr>
          <a:p>
            <a:pPr marL="332640" indent="-33264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20720" indent="-2772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08440" indent="-2214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551960" indent="-2214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1995480" indent="-2214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1995480" indent="-2214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1995480" indent="-2214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6244920"/>
            <a:ext cx="160020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6244920"/>
            <a:ext cx="21715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6244920"/>
            <a:ext cx="160020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650832D-9F6E-4DF1-B38A-98B07F44B984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1.wmf"/><Relationship Id="rId3" Type="http://schemas.openxmlformats.org/officeDocument/2006/relationships/package" Target="../embeddings/oleObject2.xlsx"/><Relationship Id="rId4" Type="http://schemas.openxmlformats.org/officeDocument/2006/relationships/image" Target="../media/image2.wmf"/><Relationship Id="rId5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123840" y="119160"/>
            <a:ext cx="3650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125280" y="2965320"/>
            <a:ext cx="3650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3" name=""/>
          <p:cNvGrpSpPr/>
          <p:nvPr/>
        </p:nvGrpSpPr>
        <p:grpSpPr>
          <a:xfrm>
            <a:off x="324000" y="3798720"/>
            <a:ext cx="4932360" cy="2895120"/>
            <a:chOff x="324000" y="3798720"/>
            <a:chExt cx="4932360" cy="2895120"/>
          </a:xfrm>
        </p:grpSpPr>
        <p:sp>
          <p:nvSpPr>
            <p:cNvPr id="44" name=""/>
            <p:cNvSpPr/>
            <p:nvPr/>
          </p:nvSpPr>
          <p:spPr>
            <a:xfrm>
              <a:off x="1749240" y="6087600"/>
              <a:ext cx="8514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</a:rPr>
                <a:t>H1299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"/>
            <p:cNvSpPr/>
            <p:nvPr/>
          </p:nvSpPr>
          <p:spPr>
            <a:xfrm>
              <a:off x="3535200" y="6051240"/>
              <a:ext cx="1197360" cy="642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</a:rPr>
                <a:t>H1299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</a:rPr>
                <a:t>ve-TGFBI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aphicFrame>
          <p:nvGraphicFramePr>
            <p:cNvPr id="46" name=""/>
            <p:cNvGraphicFramePr/>
            <p:nvPr/>
          </p:nvGraphicFramePr>
          <p:xfrm>
            <a:off x="1043280" y="3866760"/>
            <a:ext cx="4213080" cy="2333520"/>
          </p:xfrm>
          <a:graphic>
            <a:graphicData uri="http://schemas.openxmlformats.org/presentationml/2006/ole">
              <p:oleObj progId="Excel.Sheet.12" r:id="rId1" spid="">
                <p:embed/>
                <p:pic>
                  <p:nvPicPr>
                    <p:cNvPr id="47" name="" descr=""/>
                    <p:cNvPicPr/>
                    <p:nvPr/>
                  </p:nvPicPr>
                  <p:blipFill>
                    <a:blip r:embed="rId2"/>
                    <a:stretch/>
                  </p:blipFill>
                  <p:spPr>
                    <a:xfrm>
                      <a:off x="1043280" y="3866760"/>
                      <a:ext cx="4213080" cy="233352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48" name=""/>
            <p:cNvSpPr/>
            <p:nvPr/>
          </p:nvSpPr>
          <p:spPr>
            <a:xfrm>
              <a:off x="596520" y="3798720"/>
              <a:ext cx="5601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</a:rPr>
                <a:t>120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"/>
            <p:cNvSpPr/>
            <p:nvPr/>
          </p:nvSpPr>
          <p:spPr>
            <a:xfrm>
              <a:off x="596520" y="4138200"/>
              <a:ext cx="5601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"/>
            <p:cNvSpPr/>
            <p:nvPr/>
          </p:nvSpPr>
          <p:spPr>
            <a:xfrm>
              <a:off x="722880" y="4505040"/>
              <a:ext cx="4338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</a:rPr>
                <a:t>80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"/>
            <p:cNvSpPr/>
            <p:nvPr/>
          </p:nvSpPr>
          <p:spPr>
            <a:xfrm>
              <a:off x="722880" y="4844880"/>
              <a:ext cx="4338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</a:rPr>
                <a:t>60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722880" y="5184360"/>
              <a:ext cx="4338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</a:rPr>
                <a:t>40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722880" y="5536800"/>
              <a:ext cx="4338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</a:rPr>
                <a:t>20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849960" y="5878080"/>
              <a:ext cx="3070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3948840" y="4473360"/>
              <a:ext cx="3574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</a:rPr>
                <a:t>**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"/>
            <p:cNvSpPr/>
            <p:nvPr/>
          </p:nvSpPr>
          <p:spPr>
            <a:xfrm rot="16200000">
              <a:off x="-250560" y="4817520"/>
              <a:ext cx="15177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</a:rPr>
                <a:t>Cell viability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7" name=""/>
          <p:cNvSpPr/>
          <p:nvPr/>
        </p:nvSpPr>
        <p:spPr>
          <a:xfrm>
            <a:off x="2895480" y="0"/>
            <a:ext cx="3962520" cy="54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Irigoyen et al. Additional Figure 4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8" name=""/>
          <p:cNvGrpSpPr/>
          <p:nvPr/>
        </p:nvGrpSpPr>
        <p:grpSpPr>
          <a:xfrm>
            <a:off x="190440" y="601560"/>
            <a:ext cx="4546800" cy="2685600"/>
            <a:chOff x="190440" y="601560"/>
            <a:chExt cx="4546800" cy="2685600"/>
          </a:xfrm>
        </p:grpSpPr>
        <p:sp>
          <p:nvSpPr>
            <p:cNvPr id="59" name=""/>
            <p:cNvSpPr/>
            <p:nvPr/>
          </p:nvSpPr>
          <p:spPr>
            <a:xfrm>
              <a:off x="567720" y="623880"/>
              <a:ext cx="5601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</a:rPr>
                <a:t>160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aphicFrame>
          <p:nvGraphicFramePr>
            <p:cNvPr id="60" name=""/>
            <p:cNvGraphicFramePr/>
            <p:nvPr/>
          </p:nvGraphicFramePr>
          <p:xfrm>
            <a:off x="1011240" y="696960"/>
            <a:ext cx="3726000" cy="2063520"/>
          </p:xfrm>
          <a:graphic>
            <a:graphicData uri="http://schemas.openxmlformats.org/presentationml/2006/ole">
              <p:oleObj progId="Excel.Sheet.12" r:id="rId3" spid="">
                <p:embed/>
                <p:pic>
                  <p:nvPicPr>
                    <p:cNvPr id="61" name="" descr=""/>
                    <p:cNvPicPr/>
                    <p:nvPr/>
                  </p:nvPicPr>
                  <p:blipFill>
                    <a:blip r:embed="rId4"/>
                    <a:stretch/>
                  </p:blipFill>
                  <p:spPr>
                    <a:xfrm>
                      <a:off x="1011240" y="696960"/>
                      <a:ext cx="3726000" cy="206352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62" name=""/>
            <p:cNvSpPr/>
            <p:nvPr/>
          </p:nvSpPr>
          <p:spPr>
            <a:xfrm>
              <a:off x="581760" y="1044360"/>
              <a:ext cx="5601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</a:rPr>
                <a:t>120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"/>
            <p:cNvSpPr/>
            <p:nvPr/>
          </p:nvSpPr>
          <p:spPr>
            <a:xfrm>
              <a:off x="708480" y="1517760"/>
              <a:ext cx="4338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</a:rPr>
                <a:t>80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"/>
            <p:cNvSpPr/>
            <p:nvPr/>
          </p:nvSpPr>
          <p:spPr>
            <a:xfrm>
              <a:off x="708480" y="2004840"/>
              <a:ext cx="4338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</a:rPr>
                <a:t>40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"/>
            <p:cNvSpPr/>
            <p:nvPr/>
          </p:nvSpPr>
          <p:spPr>
            <a:xfrm>
              <a:off x="835200" y="2468520"/>
              <a:ext cx="3070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"/>
            <p:cNvSpPr/>
            <p:nvPr/>
          </p:nvSpPr>
          <p:spPr>
            <a:xfrm>
              <a:off x="3572280" y="601560"/>
              <a:ext cx="3574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</a:rPr>
                <a:t>**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"/>
            <p:cNvSpPr/>
            <p:nvPr/>
          </p:nvSpPr>
          <p:spPr>
            <a:xfrm>
              <a:off x="1669680" y="2644560"/>
              <a:ext cx="7246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</a:rPr>
                <a:t>A549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"/>
            <p:cNvSpPr/>
            <p:nvPr/>
          </p:nvSpPr>
          <p:spPr>
            <a:xfrm>
              <a:off x="2913120" y="2644560"/>
              <a:ext cx="1628640" cy="642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</a:rPr>
                <a:t>A549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</a:rPr>
                <a:t>TGFBI-siRNA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"/>
            <p:cNvSpPr/>
            <p:nvPr/>
          </p:nvSpPr>
          <p:spPr>
            <a:xfrm rot="16200000">
              <a:off x="-384120" y="1427040"/>
              <a:ext cx="15177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</a:rPr>
                <a:t>Cell viability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9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3-31T09:51:37Z</dcterms:created>
  <dc:creator>Centro de Tecnología Informática</dc:creator>
  <dc:description/>
  <dc:language>en-US</dc:language>
  <cp:lastModifiedBy>Centro de Tecnología Informática</cp:lastModifiedBy>
  <dcterms:modified xsi:type="dcterms:W3CDTF">2010-05-19T10:45:29Z</dcterms:modified>
  <cp:revision>5</cp:revision>
  <dc:subject/>
  <dc:title>Diapositiva 1</dc:title>
</cp:coreProperties>
</file>